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552326-9CDE-4073-91A0-02459CD9B41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7794A5-8421-4A06-91B4-A783F0E5F04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768217-8B6F-423D-9903-847461AF6C6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17B3A7-4470-4BF2-A493-90587F2758B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5EDD94-3746-49E0-AA12-4ED35A53627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A5BDFE-DD3B-4A83-803B-473E2FAB6B1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1EBD7B-3031-466B-B7B6-31F51162DB9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A0B09E-B6FD-4ECA-9B43-2C694101442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B69C32-EB49-4566-BC69-E87901365E7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ABF293-9C16-4540-B4A7-1BE93F80B5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C050D5-7373-41D9-9363-E03C232828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7DC675-1262-42B5-B770-8F9AC2A16E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CD9971A-1972-41F8-8209-855025FBF335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4"/>
          <p:cNvSpPr/>
          <p:nvPr/>
        </p:nvSpPr>
        <p:spPr>
          <a:xfrm>
            <a:off x="262800" y="1619280"/>
            <a:ext cx="300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able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3. Primer list for the long dsRNA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260280" y="1979640"/>
          <a:ext cx="6480360" cy="2887560"/>
        </p:xfrm>
        <a:graphic>
          <a:graphicData uri="http://schemas.openxmlformats.org/drawingml/2006/table">
            <a:tbl>
              <a:tblPr/>
              <a:tblGrid>
                <a:gridCol w="677880"/>
                <a:gridCol w="2863800"/>
                <a:gridCol w="2291040"/>
                <a:gridCol w="647640"/>
              </a:tblGrid>
              <a:tr h="64260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arget gen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87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rward (5'- 3'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87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verse (5'- 3'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87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CR</a:t>
                      </a:r>
                      <a:r>
                        <a:rPr b="0" i="1" lang="ja-JP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ragment length (bp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87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080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10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EGF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ATGGTGAGCAAGGGCGAGGA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CTGTACAGCTCGTCCATGCCGA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7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8080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10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Bm_T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GTACAATGGCAGTCGCAGC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CCGCTTCAGAAGATTCACTAGCA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4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080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10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Bm_Ubx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ATGAACTCTTACTTCGAGCAG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TAGGTTTGTCTTCCTCGTCTCCTGA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5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080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10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Bm_Wnt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ATGAAGTGTCTGTGGCTGTTAGTGAT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CTATAAACACGTGTGCACCACTTTTT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117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080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10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Bm_Od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ATCGCGGACAGTGATTTAGT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TTCTATACAGCCATATCGAC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1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080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884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ATGCTACGAACGCCACTAC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ACATTTATGTATCTTTGTTTGCAT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8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080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10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Bm_ago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ATGATGGACTCTCCCTCACAATC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CTGTTACGTATCCAGGCCAAACT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8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936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10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Bm_spz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AGGAAGGAAGCAATGAACCCTTCAG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AGTTTCCAGCCGTTGGGCAATACA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84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15T07:42:36Z</dcterms:created>
  <dc:creator> </dc:creator>
  <dc:description/>
  <dc:language>en-US</dc:language>
  <cp:lastModifiedBy> </cp:lastModifiedBy>
  <dcterms:modified xsi:type="dcterms:W3CDTF">2011-08-10T05:42:15Z</dcterms:modified>
  <cp:revision>6</cp:revision>
  <dc:subject/>
  <dc:title>スライド 1</dc:title>
</cp:coreProperties>
</file>